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67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94623-1255-471F-8091-CCDA48657B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A196F8-5652-49A2-9FAE-BF2787E052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4E4F07-B4BC-432E-B417-64A0886BC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BEB3AB-53C2-40A9-B926-F44BAA3BD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CDCE8-35A3-4FEE-8445-51B55F559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947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DF437-C5DC-401F-BF0F-5CF886A57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1593EA-E7DD-4AFE-A3E6-01EA4D38FD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8C5490-4F1F-4CCB-9350-FA59DADF8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58926-4542-4256-941D-549AA9CC5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E05D0-5C69-498A-B7DA-2B3D2A752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939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ED7A05-1A61-4D28-8D84-CA72750677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829D89-FBA4-4279-AAD3-88331764A1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A95437-8EBD-4E2D-809F-A578A0DEF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5A49FA-4359-44B8-B8C6-50B851451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754443-029B-4FA1-AAFC-16743F947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762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A12D1-CF46-4F54-AF15-A324B23EE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C8A8A8-F2FA-4225-88F4-D429523EC3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FE18E-B62B-46D2-B6E6-49C32B79B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9003D0-C3F0-4403-8CFD-6C42E80DE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93FE42-77A3-4A71-AA66-0119A1D30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815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70D0A-656C-4CA7-B07E-452974B47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327A70-9246-4ABC-89CE-3C0763C561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0B9A9-B191-406C-9D07-996004800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A285AB-E05D-4278-86F0-4EB1E46AE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C1F7BA-D406-45A3-8658-5F0531068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456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78BF3-E00D-4CC7-8D61-E3014A34F6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CE2224-769A-4F81-BEED-4114A00579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1B2E9B-E646-45EB-9E3E-6B8EF294DE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E15428-F5DC-4E7B-B242-E111035E5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80CD6F-54A7-46A4-A582-6A8FCE707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A69BD9-C1A1-4AC1-B2AC-568EA51D0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003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FA924D-CA87-4D45-B3F3-37AB41F709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F93DF4-42EE-41B8-9B74-F75EEA9F08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026191-C04D-4652-B1F4-655A39B448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ADFFC5-6C31-4D24-9B80-FF3F85CDC1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948CA2-A0B2-4FAC-B8CE-BB9D9A4572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DAF4CD-67B7-417C-B4CA-BBB6E373D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21A7A9-F435-49E2-927C-E54086FFB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50A670-601E-4747-BE79-FCCDBBAB8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10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C737F-DF25-4C19-85FA-FAB6BE206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60F590-F58B-4587-ABDF-E8C858EDC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3E8B1F-75F9-43DA-B173-977E4EC21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534499-8F34-4140-8E86-F849893FB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48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217682-34A7-4A6D-9BFE-BA134AFA0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11FD4E-FF18-4D56-8912-DBC8F4D4D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D02B2E-7337-4655-B833-580052062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077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7BB58-CD40-4797-9770-FD023273B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9FBBB3-CE12-42CB-850A-0F9FCBF00E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77D221-ABE8-4352-B741-09A0993412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8E208B-429A-40C9-AC9F-3A668DDAD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22B955-797D-41DB-9A17-20932F736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EF1972-5054-4BD0-8979-1C3B0CF08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319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4971B-AD39-4F5A-8F53-68647E79DF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81F542-336A-48DF-A680-0FEE9F1B62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D06C48-26C4-4968-AB3D-8879F4641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F1767-FB21-4974-A5F6-CEE522932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D38E1A-041C-4B19-9977-26F74E80ED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5778D9-130B-4FD3-A77C-47A1E0B3E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41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8922D2-4328-4CFE-AE76-39400DC6E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F8F66-391F-4DA2-A4E3-9159D4F44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8F7274-EB49-42BD-888D-F7EC3A5833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753B7-D818-4D6B-A36C-4FA56A295A83}" type="datetimeFigureOut">
              <a:rPr lang="en-US" smtClean="0"/>
              <a:t>2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5F411-F9A2-40D5-967E-F153569123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E7E664-A900-4E17-8990-98D4EBF79D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053C2-2C19-4909-874A-513F311D6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396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84D5913-166B-46F6-8485-9BD7EE6419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25" t="20688" r="25607" b="25653"/>
          <a:stretch/>
        </p:blipFill>
        <p:spPr>
          <a:xfrm>
            <a:off x="688157" y="3999322"/>
            <a:ext cx="2960016" cy="239440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FE9736B-7D10-48B6-AD1A-55E7FC34EE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66" t="20356" r="32705" b="25984"/>
          <a:stretch/>
        </p:blipFill>
        <p:spPr>
          <a:xfrm>
            <a:off x="3847708" y="3999322"/>
            <a:ext cx="2667785" cy="23944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076FD1E-EA1F-4B07-BD97-E2E66ABC576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02" t="26603" r="22593" b="24596"/>
          <a:stretch/>
        </p:blipFill>
        <p:spPr>
          <a:xfrm>
            <a:off x="3847708" y="1317395"/>
            <a:ext cx="2817043" cy="217759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5CD3594-5722-43B8-B8A6-E8AA602607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50" t="28082" r="21382" b="24596"/>
          <a:stretch/>
        </p:blipFill>
        <p:spPr>
          <a:xfrm>
            <a:off x="688156" y="1317395"/>
            <a:ext cx="2960017" cy="211160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CB74C3A-B186-4119-B79F-4BD496B2D3B1}"/>
              </a:ext>
            </a:extLst>
          </p:cNvPr>
          <p:cNvSpPr txBox="1"/>
          <p:nvPr/>
        </p:nvSpPr>
        <p:spPr>
          <a:xfrm>
            <a:off x="688156" y="1010181"/>
            <a:ext cx="266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1 Colorimetric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2E718F3-C7EE-4EDB-911F-EFB29770DCD3}"/>
              </a:ext>
            </a:extLst>
          </p:cNvPr>
          <p:cNvSpPr txBox="1"/>
          <p:nvPr/>
        </p:nvSpPr>
        <p:spPr>
          <a:xfrm>
            <a:off x="3780147" y="1010181"/>
            <a:ext cx="3334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1 Chemiluminesc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D070684-1421-42B4-AE07-8C2593D4B80E}"/>
              </a:ext>
            </a:extLst>
          </p:cNvPr>
          <p:cNvSpPr txBox="1"/>
          <p:nvPr/>
        </p:nvSpPr>
        <p:spPr>
          <a:xfrm>
            <a:off x="688156" y="3687394"/>
            <a:ext cx="266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2 Colorimetric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0BB827-A3A2-4CB8-B80B-EDEB85E4A4DE}"/>
              </a:ext>
            </a:extLst>
          </p:cNvPr>
          <p:cNvSpPr txBox="1"/>
          <p:nvPr/>
        </p:nvSpPr>
        <p:spPr>
          <a:xfrm>
            <a:off x="3411375" y="3650356"/>
            <a:ext cx="3334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2 Chemiluminescence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9F4B56D-043B-4093-B06E-1719968DDC6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1274" t="13775" r="16065" b="29697"/>
          <a:stretch/>
        </p:blipFill>
        <p:spPr>
          <a:xfrm>
            <a:off x="8446418" y="1010181"/>
            <a:ext cx="2931736" cy="230956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3F1E6CE-9C8C-4355-A999-B9E7597F8EAC}"/>
              </a:ext>
            </a:extLst>
          </p:cNvPr>
          <p:cNvSpPr txBox="1"/>
          <p:nvPr/>
        </p:nvSpPr>
        <p:spPr>
          <a:xfrm>
            <a:off x="8353717" y="618125"/>
            <a:ext cx="3334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3 Chemiluminescenc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59024E-AE59-4BBA-8947-67CF02FEE9B1}"/>
              </a:ext>
            </a:extLst>
          </p:cNvPr>
          <p:cNvSpPr txBox="1"/>
          <p:nvPr/>
        </p:nvSpPr>
        <p:spPr>
          <a:xfrm>
            <a:off x="565608" y="226243"/>
            <a:ext cx="4971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se are the uncropped blots relative to Figure 3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975F9D3-1D21-4028-8F84-349FDB96920D}"/>
              </a:ext>
            </a:extLst>
          </p:cNvPr>
          <p:cNvSpPr txBox="1"/>
          <p:nvPr/>
        </p:nvSpPr>
        <p:spPr>
          <a:xfrm>
            <a:off x="163895" y="818866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3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9494A38-A8F4-4F51-BF02-DCDB7833816D}"/>
              </a:ext>
            </a:extLst>
          </p:cNvPr>
          <p:cNvSpPr txBox="1"/>
          <p:nvPr/>
        </p:nvSpPr>
        <p:spPr>
          <a:xfrm>
            <a:off x="71325" y="3573428"/>
            <a:ext cx="822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3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7B28F18-4E3D-45EE-8148-DDBCD4130D3F}"/>
              </a:ext>
            </a:extLst>
          </p:cNvPr>
          <p:cNvSpPr txBox="1"/>
          <p:nvPr/>
        </p:nvSpPr>
        <p:spPr>
          <a:xfrm>
            <a:off x="7877298" y="398951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3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7F121FC-43B8-42A9-A9AA-5934928A42F5}"/>
              </a:ext>
            </a:extLst>
          </p:cNvPr>
          <p:cNvSpPr txBox="1"/>
          <p:nvPr/>
        </p:nvSpPr>
        <p:spPr>
          <a:xfrm>
            <a:off x="6976520" y="3687394"/>
            <a:ext cx="517777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banding pattern for p66, characterized by a major band at approximately 66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long with lower molecular weight bands and doublets (~55, 37, and 25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is consistent with previously published independent findings [PMID: 36211976] and likely reflects proteolytic degradation occurring during bacterial lysis. The relative intensity of bands below 66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pears to be protease-dependent (Fig.3D &gt;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la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t al. 2025), supporting the interpretation that these species represent degradation products rather than nonspecific reactivity.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3A2392-3B6C-4D98-8EAF-CF0299B6CABD}"/>
              </a:ext>
            </a:extLst>
          </p:cNvPr>
          <p:cNvSpPr txBox="1"/>
          <p:nvPr/>
        </p:nvSpPr>
        <p:spPr>
          <a:xfrm>
            <a:off x="1290107" y="657518"/>
            <a:ext cx="579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FlaB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D69D4F5-A541-41EE-8417-FF648D8236E7}"/>
              </a:ext>
            </a:extLst>
          </p:cNvPr>
          <p:cNvSpPr txBox="1"/>
          <p:nvPr/>
        </p:nvSpPr>
        <p:spPr>
          <a:xfrm>
            <a:off x="1340205" y="3465690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6</a:t>
            </a:r>
          </a:p>
        </p:txBody>
      </p:sp>
    </p:spTree>
    <p:extLst>
      <p:ext uri="{BB962C8B-B14F-4D97-AF65-F5344CB8AC3E}">
        <p14:creationId xmlns:p14="http://schemas.microsoft.com/office/powerpoint/2010/main" val="3047584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0</TotalTime>
  <Words>12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a Luchini</dc:creator>
  <cp:lastModifiedBy>Alessandra Luchini</cp:lastModifiedBy>
  <cp:revision>5</cp:revision>
  <dcterms:created xsi:type="dcterms:W3CDTF">2025-11-19T17:07:34Z</dcterms:created>
  <dcterms:modified xsi:type="dcterms:W3CDTF">2026-02-21T21:26:53Z</dcterms:modified>
</cp:coreProperties>
</file>